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E5A0B4-6B7E-4BF0-925E-EE932B2A8A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8EC42B-86C2-4845-B20B-8B2CDC86F7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6A0428-DE66-464B-A65C-46E4F2041E2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B51CF4-CEF4-4ADB-9379-08E262CDD9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F8965D-4C4B-4064-A823-0DCE147405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ED3DB8-C1B0-4F81-8220-71ED2E3452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A400FF-6460-40BF-A76C-520218AD14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5E5799-3C35-4C7B-9E05-FA69422BAE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E145DC-2300-4315-A7BD-043E908998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5BB7B0-58A3-47D2-8217-684774AAEE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7F32BB-CDEC-43DD-9DB7-A7A73CF3A7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E7ECEA-A228-4479-8B62-BA15A5FB9B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C445B4E-C5BA-460A-874C-F44CF500EA89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9"/>
          <p:cNvGrpSpPr/>
          <p:nvPr/>
        </p:nvGrpSpPr>
        <p:grpSpPr>
          <a:xfrm>
            <a:off x="260280" y="1258920"/>
            <a:ext cx="6410520" cy="5840280"/>
            <a:chOff x="260280" y="1258920"/>
            <a:chExt cx="6410520" cy="5840280"/>
          </a:xfrm>
        </p:grpSpPr>
        <p:pic>
          <p:nvPicPr>
            <p:cNvPr id="42" name="Picture 3" descr="17MAR08TFKAmpPlot.jpg"/>
            <p:cNvPicPr/>
            <p:nvPr/>
          </p:nvPicPr>
          <p:blipFill>
            <a:blip r:embed="rId1"/>
            <a:srcRect l="0" t="0" r="0" b="12777"/>
            <a:stretch/>
          </p:blipFill>
          <p:spPr>
            <a:xfrm>
              <a:off x="260280" y="4991760"/>
              <a:ext cx="3075120" cy="2053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5" descr="17MAR08Bile51_AmpPlot.jpg"/>
            <p:cNvPicPr/>
            <p:nvPr/>
          </p:nvPicPr>
          <p:blipFill>
            <a:blip r:embed="rId2"/>
            <a:srcRect l="0" t="0" r="0" b="12777"/>
            <a:stretch/>
          </p:blipFill>
          <p:spPr>
            <a:xfrm>
              <a:off x="3595680" y="3044880"/>
              <a:ext cx="3075120" cy="2053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6" descr="17MAR08.Bile39_AmpPlot.jpg"/>
            <p:cNvPicPr/>
            <p:nvPr/>
          </p:nvPicPr>
          <p:blipFill>
            <a:blip r:embed="rId3"/>
            <a:srcRect l="0" t="0" r="0" b="12777"/>
            <a:stretch/>
          </p:blipFill>
          <p:spPr>
            <a:xfrm>
              <a:off x="260280" y="3044880"/>
              <a:ext cx="3075120" cy="2053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7" descr="17MAR08Bile52_AmpPlot.jpg"/>
            <p:cNvPicPr/>
            <p:nvPr/>
          </p:nvPicPr>
          <p:blipFill>
            <a:blip r:embed="rId4"/>
            <a:srcRect l="0" t="0" r="0" b="12771"/>
            <a:stretch/>
          </p:blipFill>
          <p:spPr>
            <a:xfrm>
              <a:off x="3595680" y="1258920"/>
              <a:ext cx="3075120" cy="2053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9" descr="17MAR08Bile59AmpPlot.jpg"/>
            <p:cNvPicPr/>
            <p:nvPr/>
          </p:nvPicPr>
          <p:blipFill>
            <a:blip r:embed="rId5"/>
            <a:srcRect l="0" t="0" r="0" b="12771"/>
            <a:stretch/>
          </p:blipFill>
          <p:spPr>
            <a:xfrm>
              <a:off x="260280" y="1258920"/>
              <a:ext cx="3075120" cy="2053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TextBox 11"/>
            <p:cNvSpPr/>
            <p:nvPr/>
          </p:nvSpPr>
          <p:spPr>
            <a:xfrm>
              <a:off x="864720" y="1473120"/>
              <a:ext cx="970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 u="sng">
                  <a:solidFill>
                    <a:srgbClr val="000000"/>
                  </a:solidFill>
                  <a:uFillTx/>
                  <a:latin typeface="Calibri"/>
                </a:rPr>
                <a:t>Bile: Norm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13"/>
            <p:cNvSpPr/>
            <p:nvPr/>
          </p:nvSpPr>
          <p:spPr>
            <a:xfrm>
              <a:off x="4203360" y="1482480"/>
              <a:ext cx="77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 u="sng">
                  <a:solidFill>
                    <a:srgbClr val="000000"/>
                  </a:solidFill>
                  <a:uFillTx/>
                  <a:latin typeface="Calibri"/>
                </a:rPr>
                <a:t>Bile: BTC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15"/>
            <p:cNvSpPr/>
            <p:nvPr/>
          </p:nvSpPr>
          <p:spPr>
            <a:xfrm>
              <a:off x="886680" y="3330360"/>
              <a:ext cx="842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 u="sng">
                  <a:solidFill>
                    <a:srgbClr val="000000"/>
                  </a:solidFill>
                  <a:uFillTx/>
                  <a:latin typeface="Calibri"/>
                </a:rPr>
                <a:t>Bile: PSC 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6"/>
            <p:cNvSpPr/>
            <p:nvPr/>
          </p:nvSpPr>
          <p:spPr>
            <a:xfrm>
              <a:off x="4211280" y="3330360"/>
              <a:ext cx="842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 u="sng">
                  <a:solidFill>
                    <a:srgbClr val="000000"/>
                  </a:solidFill>
                  <a:uFillTx/>
                  <a:latin typeface="Calibri"/>
                </a:rPr>
                <a:t>Bile: PSC 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17"/>
            <p:cNvSpPr/>
            <p:nvPr/>
          </p:nvSpPr>
          <p:spPr>
            <a:xfrm>
              <a:off x="792000" y="5154480"/>
              <a:ext cx="9442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 u="sng">
                  <a:solidFill>
                    <a:srgbClr val="000000"/>
                  </a:solidFill>
                  <a:uFillTx/>
                  <a:latin typeface="Calibri"/>
                </a:rPr>
                <a:t>TFK-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 u="sng">
                  <a:solidFill>
                    <a:srgbClr val="000000"/>
                  </a:solidFill>
                  <a:uFillTx/>
                  <a:latin typeface="Calibri"/>
                </a:rPr>
                <a:t>BTC cell li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2" name="Picture 19" descr="PBMCMike050208_AmpPlot.jpg"/>
            <p:cNvPicPr/>
            <p:nvPr/>
          </p:nvPicPr>
          <p:blipFill>
            <a:blip r:embed="rId6"/>
            <a:srcRect l="0" t="0" r="0" b="12786"/>
            <a:stretch/>
          </p:blipFill>
          <p:spPr>
            <a:xfrm>
              <a:off x="3595680" y="5045400"/>
              <a:ext cx="3075120" cy="2053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TextBox 18"/>
            <p:cNvSpPr/>
            <p:nvPr/>
          </p:nvSpPr>
          <p:spPr>
            <a:xfrm>
              <a:off x="4181040" y="5286240"/>
              <a:ext cx="621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 u="sng">
                  <a:solidFill>
                    <a:srgbClr val="000000"/>
                  </a:solidFill>
                  <a:uFillTx/>
                  <a:latin typeface="Calibri"/>
                </a:rPr>
                <a:t>PBMC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21"/>
            <p:cNvSpPr/>
            <p:nvPr/>
          </p:nvSpPr>
          <p:spPr>
            <a:xfrm>
              <a:off x="1833480" y="2155680"/>
              <a:ext cx="55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22"/>
            <p:cNvSpPr/>
            <p:nvPr/>
          </p:nvSpPr>
          <p:spPr>
            <a:xfrm>
              <a:off x="5135760" y="2155680"/>
              <a:ext cx="55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23"/>
            <p:cNvSpPr/>
            <p:nvPr/>
          </p:nvSpPr>
          <p:spPr>
            <a:xfrm>
              <a:off x="2338920" y="2259000"/>
              <a:ext cx="44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K1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24"/>
            <p:cNvSpPr/>
            <p:nvPr/>
          </p:nvSpPr>
          <p:spPr>
            <a:xfrm>
              <a:off x="5871240" y="2259000"/>
              <a:ext cx="44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K1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25"/>
            <p:cNvSpPr/>
            <p:nvPr/>
          </p:nvSpPr>
          <p:spPr>
            <a:xfrm>
              <a:off x="2622600" y="2790720"/>
              <a:ext cx="45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D4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26"/>
            <p:cNvSpPr/>
            <p:nvPr/>
          </p:nvSpPr>
          <p:spPr>
            <a:xfrm>
              <a:off x="5880240" y="2790720"/>
              <a:ext cx="45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D4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27"/>
            <p:cNvSpPr/>
            <p:nvPr/>
          </p:nvSpPr>
          <p:spPr>
            <a:xfrm>
              <a:off x="1706400" y="3735360"/>
              <a:ext cx="55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28"/>
            <p:cNvSpPr/>
            <p:nvPr/>
          </p:nvSpPr>
          <p:spPr>
            <a:xfrm>
              <a:off x="2257920" y="3838680"/>
              <a:ext cx="44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K1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29"/>
            <p:cNvSpPr/>
            <p:nvPr/>
          </p:nvSpPr>
          <p:spPr>
            <a:xfrm>
              <a:off x="2265120" y="4370400"/>
              <a:ext cx="45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D4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30"/>
            <p:cNvSpPr/>
            <p:nvPr/>
          </p:nvSpPr>
          <p:spPr>
            <a:xfrm>
              <a:off x="5064120" y="3830760"/>
              <a:ext cx="55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31"/>
            <p:cNvSpPr/>
            <p:nvPr/>
          </p:nvSpPr>
          <p:spPr>
            <a:xfrm>
              <a:off x="5961960" y="3933720"/>
              <a:ext cx="44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K1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32"/>
            <p:cNvSpPr/>
            <p:nvPr/>
          </p:nvSpPr>
          <p:spPr>
            <a:xfrm>
              <a:off x="6107400" y="4519440"/>
              <a:ext cx="45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D4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33"/>
            <p:cNvSpPr/>
            <p:nvPr/>
          </p:nvSpPr>
          <p:spPr>
            <a:xfrm>
              <a:off x="1349280" y="5708520"/>
              <a:ext cx="55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34"/>
            <p:cNvSpPr/>
            <p:nvPr/>
          </p:nvSpPr>
          <p:spPr>
            <a:xfrm>
              <a:off x="2002320" y="5823000"/>
              <a:ext cx="44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K1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35"/>
            <p:cNvSpPr/>
            <p:nvPr/>
          </p:nvSpPr>
          <p:spPr>
            <a:xfrm>
              <a:off x="2400120" y="6513480"/>
              <a:ext cx="45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D4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36"/>
            <p:cNvSpPr/>
            <p:nvPr/>
          </p:nvSpPr>
          <p:spPr>
            <a:xfrm>
              <a:off x="4786200" y="5708520"/>
              <a:ext cx="55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37"/>
            <p:cNvSpPr/>
            <p:nvPr/>
          </p:nvSpPr>
          <p:spPr>
            <a:xfrm>
              <a:off x="5448600" y="5823000"/>
              <a:ext cx="45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D4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38"/>
            <p:cNvSpPr/>
            <p:nvPr/>
          </p:nvSpPr>
          <p:spPr>
            <a:xfrm>
              <a:off x="6071400" y="6513480"/>
              <a:ext cx="44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K1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2" name=""/>
          <p:cNvSpPr/>
          <p:nvPr/>
        </p:nvSpPr>
        <p:spPr>
          <a:xfrm>
            <a:off x="333360" y="7524720"/>
            <a:ext cx="6335640" cy="1284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542880"/>
                <a:tab algn="l" pos="712800"/>
                <a:tab algn="l" pos="893880"/>
                <a:tab algn="l" pos="1787400"/>
                <a:tab algn="l" pos="2681280"/>
                <a:tab algn="l" pos="3575160"/>
                <a:tab algn="l" pos="4468680"/>
                <a:tab algn="l" pos="5362560"/>
                <a:tab algn="l" pos="6256440"/>
                <a:tab algn="l" pos="7149960"/>
                <a:tab algn="l" pos="8043840"/>
                <a:tab algn="l" pos="8937720"/>
                <a:tab algn="l" pos="9831240"/>
                <a:tab algn="l" pos="1072512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GPADH: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house-keeping gene glyceraldehyde-3-phosphate dehydrogenase </a:t>
            </a:r>
            <a:br>
              <a:rPr sz="1200"/>
            </a:b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K-19: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ytokeratin 19, usually detected in biliary epithelium </a:t>
            </a:r>
            <a:br>
              <a:rPr sz="1200"/>
            </a:b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D45: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i="1" lang="en-GB" sz="1200" spc="-1" strike="noStrike">
                <a:solidFill>
                  <a:srgbClr val="000000"/>
                </a:solidFill>
                <a:latin typeface="Calibri"/>
              </a:rPr>
              <a:t>pan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-leucocyte marker, present on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leucocytes and their haemopoietic progenitor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spcBef>
                <a:spcPts val="751"/>
              </a:spcBef>
              <a:tabLst>
                <a:tab algn="l" pos="0"/>
                <a:tab algn="l" pos="542880"/>
                <a:tab algn="l" pos="712800"/>
                <a:tab algn="l" pos="893880"/>
                <a:tab algn="l" pos="1787400"/>
                <a:tab algn="l" pos="2681280"/>
                <a:tab algn="l" pos="3575160"/>
                <a:tab algn="l" pos="4468680"/>
                <a:tab algn="l" pos="5362560"/>
                <a:tab algn="l" pos="6256440"/>
                <a:tab algn="l" pos="7149960"/>
                <a:tab algn="l" pos="8043840"/>
                <a:tab algn="l" pos="8937720"/>
                <a:tab algn="l" pos="9831240"/>
                <a:tab algn="l" pos="1072512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Abbreviations: </a:t>
            </a:r>
            <a:br>
              <a:rPr sz="1200"/>
            </a:b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BTC = biliary tract cancer; PSC = primary sclerosing cholangitits (1: patient 1; 2: patient 2); TFK-1 = BTC cell line; PBMC = peripheral blood mononuclear cell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"/>
          <p:cNvSpPr/>
          <p:nvPr/>
        </p:nvSpPr>
        <p:spPr>
          <a:xfrm>
            <a:off x="836640" y="468360"/>
            <a:ext cx="5543640" cy="580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GAPDH, CK-19 and CD45 gene amplification plots </a:t>
            </a:r>
            <a:br>
              <a:rPr sz="1600"/>
            </a:b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on four bile samples and two control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18T12:09:02Z</dcterms:created>
  <dc:creator> Fausto Andreola</dc:creator>
  <dc:description/>
  <dc:language>en-US</dc:language>
  <cp:lastModifiedBy>Rudi</cp:lastModifiedBy>
  <dcterms:modified xsi:type="dcterms:W3CDTF">2008-03-24T00:15:01Z</dcterms:modified>
  <cp:revision>26</cp:revision>
  <dc:subject/>
  <dc:title>Slide 1</dc:title>
</cp:coreProperties>
</file>